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0D6EE2-A0C5-4787-B8EC-2E8AF74EC7C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C833B6-4CB8-427B-8FCC-C5CE3E4FCFB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5E0BB6-20CF-46F4-A3A1-15FA95357D9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53E46B-B1B2-4892-AB3E-DAB4EC81154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A68BD6-53C7-48C5-889C-9516A598D16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184070-0094-4A89-BB6F-3C5A058C6BF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C94E48-E72E-4F82-B4ED-9A4677540B8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C4F302-0D32-4D26-BFAF-2CA27343722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C10A17-8BEF-437D-93EA-12AC607B8DE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C091BB-A7E2-44B8-BE5B-770063A3AA8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003D4E-34B6-4607-8487-FD4BD1FB6FD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49BF79-AEFA-4E54-A414-C9703BDF07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等线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等线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等线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等线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等线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等线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A652512-C110-4533-BBFD-F7AE5CFA54F4}" type="slidenum">
              <a:rPr b="0" lang="zh-CN" sz="1200" spc="-1" strike="noStrike">
                <a:solidFill>
                  <a:srgbClr val="898989"/>
                </a:solidFill>
                <a:latin typeface="等线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矩形: 圆角 7"/>
          <p:cNvSpPr/>
          <p:nvPr/>
        </p:nvSpPr>
        <p:spPr>
          <a:xfrm>
            <a:off x="4327560" y="1709640"/>
            <a:ext cx="1643040" cy="457200"/>
          </a:xfrm>
          <a:prstGeom prst="roundRect">
            <a:avLst>
              <a:gd name="adj" fmla="val 16667"/>
            </a:avLst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NP genotyping and analysis</a:t>
            </a:r>
            <a:endParaRPr b="0" lang="en-US" sz="16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2" name="矩形: 圆角 9"/>
          <p:cNvSpPr/>
          <p:nvPr/>
        </p:nvSpPr>
        <p:spPr>
          <a:xfrm>
            <a:off x="1905120" y="368280"/>
            <a:ext cx="2438280" cy="1077840"/>
          </a:xfrm>
          <a:prstGeom prst="roundRect">
            <a:avLst>
              <a:gd name="adj" fmla="val 16667"/>
            </a:avLst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earching for SNPs located in 3’-UTR of </a:t>
            </a:r>
            <a:r>
              <a:rPr b="0" i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L17A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</a:t>
            </a:r>
            <a:r>
              <a:rPr b="0" i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L17F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</a:t>
            </a:r>
            <a:r>
              <a:rPr b="0" i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L17RA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, </a:t>
            </a:r>
            <a:r>
              <a:rPr b="0" i="1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L23R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in database SNP</a:t>
            </a:r>
            <a:endParaRPr b="0" lang="en-US" sz="16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3" name="矩形: 圆角 11"/>
          <p:cNvSpPr/>
          <p:nvPr/>
        </p:nvSpPr>
        <p:spPr>
          <a:xfrm>
            <a:off x="4452840" y="1023840"/>
            <a:ext cx="1392480" cy="457200"/>
          </a:xfrm>
          <a:prstGeom prst="roundRect">
            <a:avLst>
              <a:gd name="adj" fmla="val 16667"/>
            </a:avLst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NP selection</a:t>
            </a:r>
            <a:endParaRPr b="0" lang="en-US" sz="16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4" name="矩形: 圆角 12"/>
          <p:cNvSpPr/>
          <p:nvPr/>
        </p:nvSpPr>
        <p:spPr>
          <a:xfrm>
            <a:off x="4141800" y="2443320"/>
            <a:ext cx="2014560" cy="717480"/>
          </a:xfrm>
          <a:prstGeom prst="roundRect">
            <a:avLst>
              <a:gd name="adj" fmla="val 16667"/>
            </a:avLst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ositive functional miRNA-binding SNP with bigger </a:t>
            </a:r>
            <a:r>
              <a:rPr b="0" lang="en-US" sz="1600" spc="-1" strike="noStrike">
                <a:solidFill>
                  <a:srgbClr val="000000"/>
                </a:solidFill>
                <a:latin typeface="Cambria Math"/>
                <a:ea typeface="Cambria Math"/>
              </a:rPr>
              <a:t>△△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</a:t>
            </a:r>
            <a:endParaRPr b="0" lang="en-US" sz="16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5" name="矩形: 圆角 13"/>
          <p:cNvSpPr/>
          <p:nvPr/>
        </p:nvSpPr>
        <p:spPr>
          <a:xfrm>
            <a:off x="8442360" y="271440"/>
            <a:ext cx="2503440" cy="914400"/>
          </a:xfrm>
          <a:prstGeom prst="roundRect">
            <a:avLst>
              <a:gd name="adj" fmla="val 16667"/>
            </a:avLst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creening SNPs according to criteria of MAF in</a:t>
            </a:r>
            <a:r>
              <a:rPr b="0" lang="zh-CN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≥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.05 in Chinese Han population</a:t>
            </a:r>
            <a:endParaRPr b="0" lang="en-US" sz="16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6" name="矩形: 圆角 15"/>
          <p:cNvSpPr/>
          <p:nvPr/>
        </p:nvSpPr>
        <p:spPr>
          <a:xfrm>
            <a:off x="6138720" y="698400"/>
            <a:ext cx="2036880" cy="914400"/>
          </a:xfrm>
          <a:prstGeom prst="roundRect">
            <a:avLst>
              <a:gd name="adj" fmla="val 16667"/>
            </a:avLst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nding the potential miRNA-binding sites of the selected SNPs</a:t>
            </a:r>
            <a:endParaRPr b="0" lang="en-US" sz="16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47" name="矩形: 圆角 16"/>
          <p:cNvSpPr/>
          <p:nvPr/>
        </p:nvSpPr>
        <p:spPr>
          <a:xfrm>
            <a:off x="5486400" y="4270320"/>
            <a:ext cx="1393920" cy="457200"/>
          </a:xfrm>
          <a:prstGeom prst="roundRect">
            <a:avLst>
              <a:gd name="adj" fmla="val 16667"/>
            </a:avLst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Western Blot analysis </a:t>
            </a:r>
            <a:endParaRPr b="0" lang="en-US" sz="1600" spc="-1" strike="noStrike">
              <a:solidFill>
                <a:srgbClr val="000000"/>
              </a:solidFill>
              <a:latin typeface="等线"/>
            </a:endParaRPr>
          </a:p>
        </p:txBody>
      </p:sp>
      <p:cxnSp>
        <p:nvCxnSpPr>
          <p:cNvPr id="48" name="直接箭头连接符 18"/>
          <p:cNvCxnSpPr/>
          <p:nvPr/>
        </p:nvCxnSpPr>
        <p:spPr>
          <a:xfrm>
            <a:off x="4262040" y="423360"/>
            <a:ext cx="418068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49" name="直接连接符 22"/>
          <p:cNvSpPr/>
          <p:nvPr/>
        </p:nvSpPr>
        <p:spPr>
          <a:xfrm>
            <a:off x="9693360" y="1185840"/>
            <a:ext cx="0" cy="1414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cxnSp>
        <p:nvCxnSpPr>
          <p:cNvPr id="50" name="直接箭头连接符 26"/>
          <p:cNvCxnSpPr/>
          <p:nvPr/>
        </p:nvCxnSpPr>
        <p:spPr>
          <a:xfrm flipH="1">
            <a:off x="8179560" y="1301400"/>
            <a:ext cx="151380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1" name="直接箭头连接符 29"/>
          <p:cNvCxnSpPr/>
          <p:nvPr/>
        </p:nvCxnSpPr>
        <p:spPr>
          <a:xfrm flipH="1">
            <a:off x="5844600" y="1306080"/>
            <a:ext cx="294120" cy="108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2" name="直接箭头连接符 31"/>
          <p:cNvCxnSpPr>
            <a:stCxn id="43" idx="2"/>
            <a:endCxn id="41" idx="0"/>
          </p:cNvCxnSpPr>
          <p:nvPr/>
        </p:nvCxnSpPr>
        <p:spPr>
          <a:xfrm>
            <a:off x="5149080" y="1481040"/>
            <a:ext cx="360" cy="22896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53" name="直接箭头连接符 33"/>
          <p:cNvCxnSpPr>
            <a:stCxn id="41" idx="2"/>
            <a:endCxn id="44" idx="0"/>
          </p:cNvCxnSpPr>
          <p:nvPr/>
        </p:nvCxnSpPr>
        <p:spPr>
          <a:xfrm>
            <a:off x="5149080" y="2166840"/>
            <a:ext cx="360" cy="27684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54" name="矩形: 圆角 35"/>
          <p:cNvSpPr/>
          <p:nvPr/>
        </p:nvSpPr>
        <p:spPr>
          <a:xfrm>
            <a:off x="6465960" y="2600280"/>
            <a:ext cx="1557360" cy="457200"/>
          </a:xfrm>
          <a:prstGeom prst="roundRect">
            <a:avLst>
              <a:gd name="adj" fmla="val 16667"/>
            </a:avLst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ell culture and transfection</a:t>
            </a:r>
            <a:endParaRPr b="0" lang="en-US" sz="16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5" name="矩形: 圆角 20"/>
          <p:cNvSpPr/>
          <p:nvPr/>
        </p:nvSpPr>
        <p:spPr>
          <a:xfrm>
            <a:off x="100080" y="612720"/>
            <a:ext cx="1317600" cy="1378080"/>
          </a:xfrm>
          <a:custGeom>
            <a:avLst/>
            <a:gdLst>
              <a:gd name="textAreaLeft" fmla="*/ 64080 w 1317600"/>
              <a:gd name="textAreaRight" fmla="*/ 1253520 w 1317600"/>
              <a:gd name="textAreaTop" fmla="*/ 64080 h 1378080"/>
              <a:gd name="textAreaBottom" fmla="*/ 1314000 h 1378080"/>
            </a:gdLst>
            <a:ahLst/>
            <a:rect l="textAreaLeft" t="textAreaTop" r="textAreaRight" b="textAreaBottom"/>
            <a:pathLst>
              <a:path w="21600" h="22591">
                <a:moveTo>
                  <a:pt x="3600" y="0"/>
                </a:moveTo>
                <a:arcTo wR="3600" hR="3600" stAng="16200000" swAng="-5400000"/>
                <a:lnTo>
                  <a:pt x="0" y="18991"/>
                </a:lnTo>
                <a:arcTo wR="3600" hR="3600" stAng="10800000" swAng="-5400000"/>
                <a:lnTo>
                  <a:pt x="18000" y="22591"/>
                </a:lnTo>
                <a:arcTo wR="3600" hR="3600" stAng="5400000" swAng="-5400000"/>
                <a:lnTo>
                  <a:pt x="21600" y="3600"/>
                </a:lnTo>
                <a:arcTo wR="3600" hR="3600" stAng="0" swAng="-5400000"/>
                <a:close/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ssociation analysis</a:t>
            </a:r>
            <a:endParaRPr b="0" lang="en-US" sz="16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6" name="左大括号 5"/>
          <p:cNvSpPr/>
          <p:nvPr/>
        </p:nvSpPr>
        <p:spPr>
          <a:xfrm>
            <a:off x="1467000" y="271440"/>
            <a:ext cx="446040" cy="2048040"/>
          </a:xfrm>
          <a:custGeom>
            <a:avLst/>
            <a:gdLst>
              <a:gd name="textAreaLeft" fmla="*/ 285120 w 446040"/>
              <a:gd name="textAreaRight" fmla="*/ 446400 w 446040"/>
              <a:gd name="textAreaTop" fmla="*/ 11520 h 2048040"/>
              <a:gd name="textAreaBottom" fmla="*/ 2036520 h 204804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196"/>
                  <a:pt x="10800" y="392"/>
                </a:cubicBezTo>
                <a:lnTo>
                  <a:pt x="10800" y="10408"/>
                </a:lnTo>
                <a:cubicBezTo>
                  <a:pt x="10800" y="10604"/>
                  <a:pt x="5400" y="10800"/>
                  <a:pt x="0" y="10800"/>
                </a:cubicBezTo>
                <a:cubicBezTo>
                  <a:pt x="5400" y="10800"/>
                  <a:pt x="10800" y="10996"/>
                  <a:pt x="10800" y="11192"/>
                </a:cubicBezTo>
                <a:lnTo>
                  <a:pt x="10800" y="21208"/>
                </a:lnTo>
                <a:cubicBezTo>
                  <a:pt x="10800" y="21404"/>
                  <a:pt x="16200" y="21600"/>
                  <a:pt x="21600" y="21600"/>
                </a:cubicBezTo>
              </a:path>
            </a:pathLst>
          </a:cu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7" name="矩形: 圆角 23"/>
          <p:cNvSpPr/>
          <p:nvPr/>
        </p:nvSpPr>
        <p:spPr>
          <a:xfrm>
            <a:off x="7821720" y="4270320"/>
            <a:ext cx="1741320" cy="457200"/>
          </a:xfrm>
          <a:prstGeom prst="roundRect">
            <a:avLst>
              <a:gd name="adj" fmla="val 16667"/>
            </a:avLst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Luciferase report gene assay</a:t>
            </a:r>
            <a:endParaRPr b="0" lang="en-US" sz="16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58" name="直接连接符 21"/>
          <p:cNvSpPr/>
          <p:nvPr/>
        </p:nvSpPr>
        <p:spPr>
          <a:xfrm>
            <a:off x="4141800" y="3908520"/>
            <a:ext cx="454968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cxnSp>
        <p:nvCxnSpPr>
          <p:cNvPr id="59" name="直接箭头连接符 25"/>
          <p:cNvCxnSpPr>
            <a:endCxn id="57" idx="0"/>
          </p:cNvCxnSpPr>
          <p:nvPr/>
        </p:nvCxnSpPr>
        <p:spPr>
          <a:xfrm>
            <a:off x="8691120" y="3908160"/>
            <a:ext cx="1440" cy="36252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cxnSp>
        <p:nvCxnSpPr>
          <p:cNvPr id="60" name="直接箭头连接符 28"/>
          <p:cNvCxnSpPr/>
          <p:nvPr/>
        </p:nvCxnSpPr>
        <p:spPr>
          <a:xfrm flipH="1">
            <a:off x="4141080" y="3908160"/>
            <a:ext cx="11880" cy="33876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61" name="矩形: 圆角 36"/>
          <p:cNvSpPr/>
          <p:nvPr/>
        </p:nvSpPr>
        <p:spPr>
          <a:xfrm>
            <a:off x="3456000" y="4270320"/>
            <a:ext cx="1393920" cy="457200"/>
          </a:xfrm>
          <a:prstGeom prst="roundRect">
            <a:avLst>
              <a:gd name="adj" fmla="val 16667"/>
            </a:avLst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qRT-PCR analysis</a:t>
            </a:r>
            <a:endParaRPr b="0" lang="en-US" sz="16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2" name="直接连接符 46"/>
          <p:cNvSpPr/>
          <p:nvPr/>
        </p:nvSpPr>
        <p:spPr>
          <a:xfrm>
            <a:off x="5148360" y="3160800"/>
            <a:ext cx="0" cy="30168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3" name="直接连接符 48"/>
          <p:cNvSpPr/>
          <p:nvPr/>
        </p:nvSpPr>
        <p:spPr>
          <a:xfrm>
            <a:off x="7243920" y="3057480"/>
            <a:ext cx="0" cy="40500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4" name="直接连接符 50"/>
          <p:cNvSpPr/>
          <p:nvPr/>
        </p:nvSpPr>
        <p:spPr>
          <a:xfrm>
            <a:off x="5148360" y="3462480"/>
            <a:ext cx="20955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5" name="左大括号 57"/>
          <p:cNvSpPr/>
          <p:nvPr/>
        </p:nvSpPr>
        <p:spPr>
          <a:xfrm>
            <a:off x="1467000" y="2419200"/>
            <a:ext cx="446040" cy="2341800"/>
          </a:xfrm>
          <a:custGeom>
            <a:avLst/>
            <a:gdLst>
              <a:gd name="textAreaLeft" fmla="*/ 285120 w 446040"/>
              <a:gd name="textAreaRight" fmla="*/ 446400 w 446040"/>
              <a:gd name="textAreaTop" fmla="*/ 11520 h 2341800"/>
              <a:gd name="textAreaBottom" fmla="*/ 2330280 h 234180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172"/>
                  <a:pt x="10800" y="343"/>
                </a:cubicBezTo>
                <a:lnTo>
                  <a:pt x="10800" y="10457"/>
                </a:lnTo>
                <a:cubicBezTo>
                  <a:pt x="10800" y="10629"/>
                  <a:pt x="5400" y="10800"/>
                  <a:pt x="0" y="10800"/>
                </a:cubicBezTo>
                <a:cubicBezTo>
                  <a:pt x="5400" y="10800"/>
                  <a:pt x="10800" y="10972"/>
                  <a:pt x="10800" y="11143"/>
                </a:cubicBezTo>
                <a:lnTo>
                  <a:pt x="10800" y="21257"/>
                </a:lnTo>
                <a:cubicBezTo>
                  <a:pt x="10800" y="21429"/>
                  <a:pt x="16200" y="21600"/>
                  <a:pt x="21600" y="21600"/>
                </a:cubicBezTo>
              </a:path>
            </a:pathLst>
          </a:cu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6" name="矩形: 圆角 58"/>
          <p:cNvSpPr/>
          <p:nvPr/>
        </p:nvSpPr>
        <p:spPr>
          <a:xfrm>
            <a:off x="166680" y="2900520"/>
            <a:ext cx="1251000" cy="1377720"/>
          </a:xfrm>
          <a:custGeom>
            <a:avLst/>
            <a:gdLst>
              <a:gd name="textAreaLeft" fmla="*/ 60840 w 1251000"/>
              <a:gd name="textAreaRight" fmla="*/ 1190160 w 1251000"/>
              <a:gd name="textAreaTop" fmla="*/ 60840 h 1377720"/>
              <a:gd name="textAreaBottom" fmla="*/ 1316880 h 1377720"/>
            </a:gdLst>
            <a:ahLst/>
            <a:rect l="textAreaLeft" t="textAreaTop" r="textAreaRight" b="textAreaBottom"/>
            <a:pathLst>
              <a:path w="21600" h="23787">
                <a:moveTo>
                  <a:pt x="3600" y="0"/>
                </a:moveTo>
                <a:arcTo wR="3600" hR="3600" stAng="16200000" swAng="-5400000"/>
                <a:lnTo>
                  <a:pt x="0" y="20187"/>
                </a:lnTo>
                <a:arcTo wR="3600" hR="3600" stAng="10800000" swAng="-5400000"/>
                <a:lnTo>
                  <a:pt x="18000" y="23787"/>
                </a:lnTo>
                <a:arcTo wR="3600" hR="3600" stAng="5400000" swAng="-5400000"/>
                <a:lnTo>
                  <a:pt x="21600" y="3600"/>
                </a:lnTo>
                <a:arcTo wR="3600" hR="3600" stAng="0" swAng="-5400000"/>
                <a:close/>
              </a:path>
            </a:pathLst>
          </a:cu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unctional study</a:t>
            </a:r>
            <a:endParaRPr b="0" lang="en-US" sz="1600" spc="-1" strike="noStrike">
              <a:solidFill>
                <a:srgbClr val="000000"/>
              </a:solidFill>
              <a:latin typeface="等线"/>
            </a:endParaRPr>
          </a:p>
        </p:txBody>
      </p:sp>
      <p:cxnSp>
        <p:nvCxnSpPr>
          <p:cNvPr id="67" name="直接箭头连接符 2"/>
          <p:cNvCxnSpPr>
            <a:endCxn id="47" idx="0"/>
          </p:cNvCxnSpPr>
          <p:nvPr/>
        </p:nvCxnSpPr>
        <p:spPr>
          <a:xfrm flipH="1">
            <a:off x="6183360" y="3908160"/>
            <a:ext cx="12600" cy="362520"/>
          </a:xfrm>
          <a:prstGeom prst="straightConnector1">
            <a:avLst/>
          </a:prstGeom>
          <a:ln w="6480">
            <a:solidFill>
              <a:srgbClr val="000000"/>
            </a:solidFill>
            <a:miter/>
            <a:tailEnd len="med" type="triangle" w="med"/>
          </a:ln>
        </p:spPr>
      </p:cxnSp>
      <p:sp>
        <p:nvSpPr>
          <p:cNvPr id="68" name="直接连接符 27"/>
          <p:cNvSpPr/>
          <p:nvPr/>
        </p:nvSpPr>
        <p:spPr>
          <a:xfrm flipV="1">
            <a:off x="6195960" y="3462120"/>
            <a:ext cx="0" cy="44604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等线"/>
            </a:endParaRPr>
          </a:p>
        </p:txBody>
      </p:sp>
      <p:sp>
        <p:nvSpPr>
          <p:cNvPr id="69" name="文本框 1"/>
          <p:cNvSpPr/>
          <p:nvPr/>
        </p:nvSpPr>
        <p:spPr>
          <a:xfrm>
            <a:off x="282600" y="5006880"/>
            <a:ext cx="11322000" cy="1067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URE 1: The flow chart of the study experiments. The experiments mainly consist of two parts: association analysis for studying the associations between functional miRNA-binding sites single nucleotide polymorphisms (SNPs) with gastric cancer risk; functional study for preliminary verifying the regulatory role of miRNA on its corresponding positive SNPs.</a:t>
            </a:r>
            <a:endParaRPr b="0" lang="en-US" sz="1600" spc="-1" strike="noStrike">
              <a:solidFill>
                <a:srgbClr val="000000"/>
              </a:solidFill>
              <a:latin typeface="等线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等线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7-05T13:11:58Z</dcterms:created>
  <dc:creator>ZZU</dc:creator>
  <dc:description/>
  <dc:language>en-US</dc:language>
  <cp:lastModifiedBy>ZZU</cp:lastModifiedBy>
  <dcterms:modified xsi:type="dcterms:W3CDTF">2017-08-03T00:11:11Z</dcterms:modified>
  <cp:revision>16</cp:revision>
  <dc:subject/>
  <dc:title>PowerPoint 演示文稿</dc:title>
</cp:coreProperties>
</file>